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6D5E05-EEC7-4830-9EDF-A9DFDA99251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EA5B2-9644-442C-BE37-27195D145FB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39715-4AB6-4C7C-A18D-8D8DE158C78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E16B3C9-12AD-431D-99C2-072B29C6484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3F2E7C-A56B-41D4-BF95-D25527E0B6A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A1652-E7CC-4021-828E-407CE3AD720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00E509-67C5-402A-8D30-47F1B55BC1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940623-093D-4D77-9323-54C0BCDCB81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5998C7D-20F1-4B2E-AA3F-C5BF5B71918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7616D6-B56A-4D9E-8596-26CC569A03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0084B0B-8447-4618-B30D-B7A44028CD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70EF0-EE45-44C9-B12F-488A167250A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6966607-1DB6-45EB-80B7-3FD6FB4DC7E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3360" y="684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91800" y="585720"/>
            <a:ext cx="127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A) CN gai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08000" y="1187280"/>
          <a:ext cx="8940600" cy="5210280"/>
        </p:xfrm>
        <a:graphic>
          <a:graphicData uri="http://schemas.openxmlformats.org/drawingml/2006/table">
            <a:tbl>
              <a:tblPr/>
              <a:tblGrid>
                <a:gridCol w="2987640"/>
                <a:gridCol w="2976480"/>
                <a:gridCol w="1919520"/>
                <a:gridCol w="1056960"/>
              </a:tblGrid>
              <a:tr h="2613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tochines/growth facto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kina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ncogen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S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49611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GRP, AMBN, AMELX, AMH, APLN, AREG, AVP, AZU1, BMP1, BMP15, BMP2, BMP3, BMP4, BMP5, BMP7, BTC, C19orf10, C3, C5, CCL17, CCL19, CCL21, CCL22, CCL24, CCL25, CCL26, CCL27, CCL28, CD320, CD40LG, CD70, CER1, CGB, CGB1, CGB2, CGB5, CGB7, CGB8, CHGA, CHGB, CKLF, CLEC11A, CMA1, CMTM1, CMTM2, CMTM3, CMTM4, CMTM5, CRH, CSF2, CSH1, CSH2, CSHL1, CTF1, CTSG, CX3CL1, CXCL1, CXCL10, CXCL11, CXCL12, CXCL13, CXCL14, CXCL17, CXCL2, CXCL3, CXCL5, CXCL6, CXCL9, DEFA1, DEFA3, DEFA5, DEFB1, DEFB103A, DEFB104A, DEFB4, EBI3, EDN3, EGF, EPGN, EPO, EREG, ESM1, FAM3B, FAM3C, FGF1, FGF10, FGF13, FGF16, FGF17, FGF18, FGF2, FGF20, FGF21, FGF22, FGF23, FGF5, FGF6, FGF8, FIGF, FIGNL2, FLT3LG, GDF1, GDF10, GDF11, GDF15, GDF2, GDF3, GDF5, GDF6, GDF9, GDNF, GH1, GH2, GHRH, GMFB, GMFG, GNRH1, GNRH2, GPHB5, GPI, HAMP, HBEGF, HGF, HTN3, IAPP, IFNA1, IFNA10, IFNA13, IFNA14, IFNA16, IFNA17, IFNA2, IFNA21, IFNA4, IFNA5, IFNA6, IFNA7, IFNA8, IFNB1, IFNE, IFNG, IFNK, IFNW1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F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IL12B, IL13, IL15, IL17B, IL17C, IL2, IL21, IL22, IL23A, IL25, IL26, IL27, IL28A, IL28B, IL29, IL3, IL31, IL32, IL33, IL34, IL4, IL5, IL6, IL6ST, IL7, IL8, IL9, INHBA, INHBC, INHBE, INSL3, INSL4, INSL6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AG1, JAG2,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KGFLP1, KGFLP2, KITLG, LACRT, LECT2, LEP, LHB, LRSAM1, LTBP2, LTBP4, MIA, NAMPT, NDP, NODAL, NOV, NPFF, NPY, NRG1, NRG2, NRG3, NRTN, NTF3, NTF4, NTS, NUDT6, OGN, OSGIN1, OXT, P11, PDGFA, PDGFC, PDGFRA, PDGFRB, PDGFRL, PDYN, PENK, PF4, PF4V1, PGF, PLAU, PMCH, PPBP, PPBPL1, PPBPL2, PSPN, PTH2, PTHLH, PTN, QRFP, RABEP2, RETN, RLN1, RLN2, RLN3, RNASE2, SBDS, SCGB3A1, SECTM1, SEMA3A, SEMA3C, SEMA3D, SEMA3E, SEMA4D, SEMA4G, SEMA5A, SEMA6A, SEMA6B, SLIT1, SLIT2, SPP1, STC1, STC2, TAC1, TDGF3, TG, TGFB1, TGFB3, TNC, TNFRSF11B, TNFSF14, TNFSF15, TNFSF8, TNFSF9, TOR2A, TSLP, UCN3, VEGFC, VGF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TK, ABL1, ACVR1B, ACVRL1, ADCK1, ADCK2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KT1, AKT2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ALPK1, AMHR2, ARAF, AURKA, AXL, BCKDK, BLK, BMP2K, BMPR1B, BMX, BRAF, BRD3, BRD4, BTK, C9orf96, CAMK1D, CAMK2A, CAMK2B, CAMK2D, CAMK2G, CAMK4, CAMKK2, CASK, CDC42BPB, CDK10, CDK13, CDK14, CDK16, CDK17, CDK2, CDK20, CDK3, CDK4, CDK5, CDK6, CDK7, CDK9, CDKL1, CDKL2, CDKL3, CDKL5, CHUK, CIT, CLK4, CSF1R, CSNK1A1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NK1D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NK1G2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CSNK1G3, CSNK2A1, CSNK2A2, DAPK1, DAPK3, DCLK2, DMPK, DYRK1A, DYRK1B, DYRK2, DYRK4, EEF2K, EGFR, EIF2AK1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HA1, EPHA5, EPHA6, EPHB4, EPHB6,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BB3, ERN1, ERN2, FASTK, FER, FGFR1, FGFR2, FGFR3, FGFR4, FLT4, GAK, GRK4, GRK5, GRK6, GSK3A, GUCY2C, GUCY2F, HCK, HIPK2, HIPK4, HSPB8, HUNK, IKBKB, INSR, IRAK1, IRAK3, IRAK4, ITK, JAK2, JAK3, KDR, KIT, KSR2, LIMK1, LMTK2, LMTK3, LRRK2, LYN, MAP2K2, MAP2K6, MAP2K7, MAP3K1, MAP3K10, MAP3K12, MAP3K15, MAP3K3, MAP3K9, MAP4K1, MAP4K5, MAPK10, MAPK3, MAPK9, MAPKAPK5, MARK3, MARK4, MAST1, MAST3, MAST4, MATK, MELK, MET, MGC42105, MKNK2, MLKL, MOS, MST4, MUSK, MYLK2, MYLK3, MYO3A, NEK1, NEK4, NEK6, NEK9, NPR2, NRK, NTRK2, NUAK1, NUMBL, PAK3, PAK4, PAK7, PDGFRA, PDGFRB, PDK3, PDK4, PDPK1, PHKG1, PHKG2, PIM2, PKMYT1, PKN1, PKN3, PLK1, PLK2, PLK4, PNCK, PRKAA1, PRKACA, PRKACG, PRKCA, PRKCB, PRKCG, PRKCH, PRKCQ, PRKD1, PRKD2, PRKDC, PRKG1, PRKG2, PRKX, PRKY, PSKH1, PSKH2, PTK2, PTK6, RAGE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RIOK2, RIPK2, RIPK3, RIPK4, ROR2, RPS6KA3, RPS6KA5, RPS6KA6, RPS6KL1, SBK1, SCYL2, SGK196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GK2, SGK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SIK1, SLK, SMG1, SRC, SRMS, SRPK2, STK10, STK11, STK17A, STK3, STK31, STK32A, STK32B, STK32C, STK35, STK38L, STK4, STRADA, STYK1, SYK, TAF1, TAF1L, TAOK2, TAOK3, TBCK, TBK1, TEC, TEK, TESK1, TGFBR1, TLK2, TP53RK, TRIB1, TRIB3, TRIM24, TRIO, TRPM6, TRRAP, TSSK1B, TSSK4, TSSK6, TWF1, TXK, TYK2, ULK1, VRK1, VRK3, WEE2, WNK1, WNK2, WNK3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01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BL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ACSL6, AFF1, AFF4, AKAP9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KT1, AKT2, 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HGAP26, ASPSCR1, ATF1, BCL11B, BCL3, BCL7A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AF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BRD3, BRD4, BTG1, CANT1, CARD11, CBFA2T3, CBFB, CCNB1IP1, CCND2, CD74, CD79A, CD79B, CDH11, CDK4, CDK6, CEBPA, CEP110, CHCHD7, CHIC2, CIC, CIITA, CLTC, COX6C, CREB3L2, CREBBP, CRLF2, CRTC1, DDIT3, DDX5, DUX4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GFR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ELF4, ELL, ELN, ERC1, ERG, ETV1, ETV6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GFR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GFR2, FGFR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FIP1L1, FNBP1, FOXO4, FSTL3, FUS, GATA1, GNAQ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AS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GOLGA5, GPHN, HERPUD1, HIP1, HMGA2, HNRNPA2B1, HOOK3, HOXA11, HOXA13, HOXA9, HOXC11, HOXC13, HSP90AA1, IKZF1, IL2, IL21R, IL6ST, ITK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AK2, JAK3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JAZF1, KDM5A, KDR, KIAA1549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IT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KLK2, KRAS, KTN1, LIFR, LPP, LYL1, MAF, MAFB, MDM2, MET, MLLT1, MLLT3, MNX1, MSN, MTCP1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C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MYH11, MYST3, MYST4, NACA, NCOA2, NFIB, NFKB2, NIN, NONO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OTCH1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NPM1, NR4A3, NSD1, NUP214, OLIG2, OMD, P2RY8, PAX5, PCM1, PDGFRA, PDGFRB, PLAG1, PSIP1, PTPN11, RAD51L1, RANBP17, RAP1GDS1, </a:t>
                      </a:r>
                      <a:r>
                        <a:rPr b="1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ET</a:t>
                      </a:r>
                      <a:r>
                        <a:rPr b="0" lang="en-US" sz="8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RHOH, RNF213, RUNX1, RUNX1T1, SET, SH3GL1, SMO, SS18L1, SSX1, SSX2, SSX4, SYK, TAL2, TCEA1, TCF3, TCL1A, TCL6, TET1, TFE3, TLX1, TLX3, TMPRSS2, TNFRSF17, TOP1, TPM4, TRIM24, TRIP11, TSHR, WHSC1, WHSC1L1, ZNF331, ZNF384</a:t>
                      </a:r>
                      <a:endParaRPr b="0" lang="en-US" sz="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PC, ASXL1, BRIP1, CBLC, CDH1, CDKN2A, CYLD, DICER1,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CC2, ERCC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XT1, FAM123B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NCA, FANCC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ANCG, FAS,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FBXW7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GATA3,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NF1A, KDM5C,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DM6A, KLF6,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BN, PALB2, 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OX2B, PIK3R1, PMS2, PRF1, PTCH1,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TEN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SBDS, SMARCA4, SOCS1, STK1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UFU, TET2, </a:t>
                      </a:r>
                      <a:r>
                        <a:rPr b="1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SC1, TSC2</a:t>
                      </a:r>
                      <a:r>
                        <a:rPr b="0" lang="en-US" sz="9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WRN, XPA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24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"/>
          <p:cNvSpPr/>
          <p:nvPr/>
        </p:nvSpPr>
        <p:spPr>
          <a:xfrm>
            <a:off x="3643920" y="861840"/>
            <a:ext cx="182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Gene family analy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" descr=""/>
          <p:cNvPicPr/>
          <p:nvPr/>
        </p:nvPicPr>
        <p:blipFill>
          <a:blip r:embed="rId1"/>
          <a:stretch/>
        </p:blipFill>
        <p:spPr>
          <a:xfrm>
            <a:off x="0" y="2362320"/>
            <a:ext cx="4427640" cy="3297240"/>
          </a:xfrm>
          <a:prstGeom prst="rect">
            <a:avLst/>
          </a:prstGeom>
          <a:ln w="0">
            <a:noFill/>
          </a:ln>
        </p:spPr>
      </p:pic>
      <p:grpSp>
        <p:nvGrpSpPr>
          <p:cNvPr id="46" name=""/>
          <p:cNvGrpSpPr/>
          <p:nvPr/>
        </p:nvGrpSpPr>
        <p:grpSpPr>
          <a:xfrm>
            <a:off x="4332240" y="2421000"/>
            <a:ext cx="4703400" cy="3168720"/>
            <a:chOff x="4332240" y="2421000"/>
            <a:chExt cx="4703400" cy="3168720"/>
          </a:xfrm>
        </p:grpSpPr>
        <p:pic>
          <p:nvPicPr>
            <p:cNvPr id="47" name="" descr=""/>
            <p:cNvPicPr/>
            <p:nvPr/>
          </p:nvPicPr>
          <p:blipFill>
            <a:blip r:embed="rId2"/>
            <a:stretch/>
          </p:blipFill>
          <p:spPr>
            <a:xfrm>
              <a:off x="4332240" y="2421000"/>
              <a:ext cx="4703400" cy="31687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8" name=""/>
            <p:cNvSpPr/>
            <p:nvPr/>
          </p:nvSpPr>
          <p:spPr>
            <a:xfrm>
              <a:off x="6524280" y="3395880"/>
              <a:ext cx="2033280" cy="26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6522840" y="3660120"/>
              <a:ext cx="2033280" cy="26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6522840" y="3922920"/>
              <a:ext cx="2033280" cy="26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6522840" y="4187520"/>
              <a:ext cx="2033280" cy="26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6522840" y="4876200"/>
              <a:ext cx="2033280" cy="264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3" name=""/>
          <p:cNvSpPr/>
          <p:nvPr/>
        </p:nvSpPr>
        <p:spPr>
          <a:xfrm>
            <a:off x="1040400" y="1773360"/>
            <a:ext cx="1561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Pathway analy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502600" y="1773360"/>
            <a:ext cx="220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Network process analy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63360" y="9684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91800" y="585720"/>
            <a:ext cx="127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A) CN gain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"/>
          <p:cNvSpPr/>
          <p:nvPr/>
        </p:nvSpPr>
        <p:spPr>
          <a:xfrm>
            <a:off x="99360" y="590400"/>
            <a:ext cx="1366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B) CN loss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8" name=""/>
          <p:cNvGraphicFramePr/>
          <p:nvPr/>
        </p:nvGraphicFramePr>
        <p:xfrm>
          <a:off x="144360" y="1550880"/>
          <a:ext cx="8845560" cy="3246480"/>
        </p:xfrm>
        <a:graphic>
          <a:graphicData uri="http://schemas.openxmlformats.org/drawingml/2006/table">
            <a:tbl>
              <a:tblPr/>
              <a:tblGrid>
                <a:gridCol w="2219400"/>
                <a:gridCol w="3362400"/>
                <a:gridCol w="2109600"/>
                <a:gridCol w="1154160"/>
              </a:tblGrid>
              <a:tr h="32076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Cytochines/growth factor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Protein kinas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Oncogen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TSG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solidFill>
                      <a:srgbClr val="dddddd"/>
                    </a:solidFill>
                  </a:tcPr>
                </a:tc>
              </a:tr>
              <a:tr h="29257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DM2, AGT, ANGPTL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TN, BMP8A, BMP8B, CCL1, CCL11, CCL14, CCL14-CCL15, CCL15, CCL16, CCL18, CCL2, CCL23, CCL3, CCL3L1, CCL3L3, CCL4, CCL4L1, CCL4L2, CCL5, CCL7, CCL8, CLCF1, CORT, CSF3, CSH1, CSH2, CSHL1, CXCL16, EDN2, FGF11, FGF14, FGF9, GAL, GAST, GH1, GH2, GIP, GPHA2, GRN, GUCA2A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F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IL17D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, INS-IGF2,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SL5, KL, LEFTY1, LEFTY2, LIF, LTBP3, MIF, NPPA, NPPB, NPPC, OSM, PDGFB, PPY, PRLH, RABEP1, SCT, SECTM1, TNFSF11, TNFSF12, TNFSF13, TNFSF13B, TXLNA, TYMP, UTS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ATK, ADRBK1, ADRBK2, ALPK2, ATM, AURKB, BCR, BRDT, BRSK2, CABC1, CAMK2G, CAMKK1, CDC42BPA, CDC42BPG, CDC7, CDK11A, CDK12, CDK3, CDK8, CHEK1, CHEK2, CLK3, CLUL1, CSNK1A1L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SNK1D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CSNK1E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HA10, EPHA2, EPHA8, EPHB2,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BB2, ERN1, FGR, FLT1, FLT3, GRK1, GSG2, GUCY2D, JAK1, KIAA1804, KSR1, LATS1, LATS2, LCK, LIMK2, MAP2K1, MAP2K3, MAP2K4, MAP2K5, MAP2K6, MAP3K11, MAP3K14, MAP3K3, MAP3K6, MAP4K2, MAPK1, MAPK11, MAPK12, MAPK4, MAPK7, MARK2, MAST2, MELK, MINK1, MKNK1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TOR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NEK3, NEK5, NEK8, NLK, NPR1, OBSCN, PASK, PDIK1L, PDK2, PIM3, PINK1, PLK3, PRKAA2, PRKCA, PRKCB, PRKCZ, PRKY, RIOK3, ROCK1, ROR1, RPS6KA1, RPS6KB2, SCYL1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GK1,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GK269, STK16, STK24, STK25, STK36, STK40, STRADA, TAOK1, TESK2, TEX14, TIE1, TLK2, TNK1, TSSK2, TSSK3, ULK2, WEE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RHGEF12, ASPSCR1, BCL2, BCR, CANT1, CARS, CD79B, CDX2, CLTC, CLTCL1, COL1A1, CREBBP, CRLF2, CYTSB, DDX10, DDX5, ELF4, EPS15, ERBB2, ETV4, EWSR1, FEV, FLI1, FLT3, FOXO1, GAS7, GATA1, HLF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RAS, 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JAK1, JUN, KDSR, LASP1, LCK, LCP1, LHFP, LPP, MDS2, MKL1, MLLT6, MN1, MPL, MYCL1, MYH9, NCOA1, NONO, NUP98, P2RY8, PATZ1, PAX7, PDGFB, PER1, PRDM16, RABEP1, RARA, RNF213, RPL22,  SEPT5, SEPT9, SFPQ, SS18, STIL, SUZ12, TAF15, TAL1, THRAP3, ZMYM2, ZNF5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spcBef>
                          <a:spcPts val="249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M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RCA1, BRCA2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BRIP1, CDKN2A, CDKN2C, CHEK2, EP300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CC5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, MAP2K4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EN1,</a:t>
                      </a: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MUTYH, NF1, NF2, RB1, SDHAF2, SDHB, SMAD4, SMARCB1, </a:t>
                      </a: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59" name=""/>
          <p:cNvSpPr/>
          <p:nvPr/>
        </p:nvSpPr>
        <p:spPr>
          <a:xfrm>
            <a:off x="3643920" y="1154160"/>
            <a:ext cx="1829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Gene family analy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3360" y="9684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" name="" descr=""/>
          <p:cNvPicPr/>
          <p:nvPr/>
        </p:nvPicPr>
        <p:blipFill>
          <a:blip r:embed="rId1"/>
          <a:stretch/>
        </p:blipFill>
        <p:spPr>
          <a:xfrm>
            <a:off x="71280" y="2421000"/>
            <a:ext cx="4356360" cy="3247920"/>
          </a:xfrm>
          <a:prstGeom prst="rect">
            <a:avLst/>
          </a:prstGeom>
          <a:ln w="0">
            <a:noFill/>
          </a:ln>
        </p:spPr>
      </p:pic>
      <p:pic>
        <p:nvPicPr>
          <p:cNvPr id="62" name="" descr=""/>
          <p:cNvPicPr/>
          <p:nvPr/>
        </p:nvPicPr>
        <p:blipFill>
          <a:blip r:embed="rId2"/>
          <a:stretch/>
        </p:blipFill>
        <p:spPr>
          <a:xfrm>
            <a:off x="4427640" y="2492280"/>
            <a:ext cx="4537080" cy="3281400"/>
          </a:xfrm>
          <a:prstGeom prst="rect">
            <a:avLst/>
          </a:prstGeom>
          <a:ln w="0">
            <a:noFill/>
          </a:ln>
        </p:spPr>
      </p:pic>
      <p:sp>
        <p:nvSpPr>
          <p:cNvPr id="63" name=""/>
          <p:cNvSpPr/>
          <p:nvPr/>
        </p:nvSpPr>
        <p:spPr>
          <a:xfrm>
            <a:off x="61200" y="590400"/>
            <a:ext cx="1366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B) CN losses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040400" y="1773360"/>
            <a:ext cx="1561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Pathway analy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5502600" y="1773360"/>
            <a:ext cx="22075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400" spc="-1" strike="noStrike">
                <a:solidFill>
                  <a:srgbClr val="000000"/>
                </a:solidFill>
                <a:latin typeface="Arial"/>
              </a:rPr>
              <a:t>Network process analysi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3360" y="9684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Figure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8T16:36:31Z</dcterms:created>
  <dc:creator>Ronchi_C</dc:creator>
  <dc:description/>
  <dc:language>en-US</dc:language>
  <cp:lastModifiedBy>cristina</cp:lastModifiedBy>
  <dcterms:modified xsi:type="dcterms:W3CDTF">2013-08-02T17:37:06Z</dcterms:modified>
  <cp:revision>15</cp:revision>
  <dc:subject/>
  <dc:title>Folie 1</dc:title>
</cp:coreProperties>
</file>